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4" r:id="rId2"/>
  </p:sldIdLst>
  <p:sldSz cx="7559675" cy="14400213"/>
  <p:notesSz cx="666273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05" userDrawn="1">
          <p15:clr>
            <a:srgbClr val="A4A3A4"/>
          </p15:clr>
        </p15:guide>
        <p15:guide id="2" pos="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892"/>
    <a:srgbClr val="D1E0F3"/>
    <a:srgbClr val="C6D9F0"/>
    <a:srgbClr val="99BAE3"/>
    <a:srgbClr val="A2C1E6"/>
    <a:srgbClr val="C1D6EF"/>
    <a:srgbClr val="92C4C3"/>
    <a:srgbClr val="7DB8B6"/>
    <a:srgbClr val="96C6C5"/>
    <a:srgbClr val="E9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49F8874-E7B7-42F1-BB7D-FF5A491A0CB3}" v="8" dt="2022-04-26T07:55:17.3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34" autoAdjust="0"/>
    <p:restoredTop sz="96337" autoAdjust="0"/>
  </p:normalViewPr>
  <p:slideViewPr>
    <p:cSldViewPr snapToGrid="0" showGuides="1">
      <p:cViewPr varScale="1">
        <p:scale>
          <a:sx n="52" d="100"/>
          <a:sy n="52" d="100"/>
        </p:scale>
        <p:origin x="3600" y="90"/>
      </p:cViewPr>
      <p:guideLst>
        <p:guide orient="horz" pos="1905"/>
        <p:guide pos="1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DE00BB-2EDC-4267-AE91-B482A1907D02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452688" y="1241425"/>
            <a:ext cx="17573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76788"/>
            <a:ext cx="5329238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975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34C33D-8904-46A7-912A-36A40FF6BA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114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452688" y="1241425"/>
            <a:ext cx="1757362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34C33D-8904-46A7-912A-36A40FF6BAF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9093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2356703"/>
            <a:ext cx="6425724" cy="501340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7563446"/>
            <a:ext cx="5669756" cy="3476717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230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203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766678"/>
            <a:ext cx="1630055" cy="1220351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766678"/>
            <a:ext cx="4795669" cy="12203515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909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111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3590057"/>
            <a:ext cx="6520220" cy="5990088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9636813"/>
            <a:ext cx="6520220" cy="315004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018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333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66681"/>
            <a:ext cx="6520220" cy="278337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3530053"/>
            <a:ext cx="3198096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5260078"/>
            <a:ext cx="3198096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3530053"/>
            <a:ext cx="3213847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5260078"/>
            <a:ext cx="3213847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7819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78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2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2073367"/>
            <a:ext cx="3827085" cy="10233485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603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2073367"/>
            <a:ext cx="3827085" cy="10233485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014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766681"/>
            <a:ext cx="652022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3833390"/>
            <a:ext cx="652022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13346867"/>
            <a:ext cx="25513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83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7" name="Gruppieren 136"/>
          <p:cNvGrpSpPr/>
          <p:nvPr/>
        </p:nvGrpSpPr>
        <p:grpSpPr>
          <a:xfrm>
            <a:off x="565249" y="8892987"/>
            <a:ext cx="4493237" cy="1490205"/>
            <a:chOff x="6882645" y="1969748"/>
            <a:chExt cx="4493237" cy="1490205"/>
          </a:xfrm>
        </p:grpSpPr>
        <p:sp>
          <p:nvSpPr>
            <p:cNvPr id="138" name="Rechteck 137"/>
            <p:cNvSpPr/>
            <p:nvPr/>
          </p:nvSpPr>
          <p:spPr>
            <a:xfrm>
              <a:off x="7838204" y="3115829"/>
              <a:ext cx="181234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6882645" y="2397226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140" name="Textfeld 139"/>
            <p:cNvSpPr txBox="1"/>
            <p:nvPr/>
          </p:nvSpPr>
          <p:spPr>
            <a:xfrm>
              <a:off x="10404140" y="2397224"/>
              <a:ext cx="9717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ryptic exon 5</a:t>
              </a:r>
            </a:p>
          </p:txBody>
        </p:sp>
        <p:sp>
          <p:nvSpPr>
            <p:cNvPr id="141" name="Textfeld 140"/>
            <p:cNvSpPr txBox="1"/>
            <p:nvPr/>
          </p:nvSpPr>
          <p:spPr>
            <a:xfrm>
              <a:off x="6882645" y="2681445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42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142" name="Gruppieren 141"/>
            <p:cNvGrpSpPr/>
            <p:nvPr/>
          </p:nvGrpSpPr>
          <p:grpSpPr>
            <a:xfrm>
              <a:off x="6970393" y="2281506"/>
              <a:ext cx="4320000" cy="102575"/>
              <a:chOff x="6970393" y="2281506"/>
              <a:chExt cx="5112000" cy="102575"/>
            </a:xfrm>
          </p:grpSpPr>
          <p:cxnSp>
            <p:nvCxnSpPr>
              <p:cNvPr id="145" name="Gerader Verbinder 144"/>
              <p:cNvCxnSpPr/>
              <p:nvPr/>
            </p:nvCxnSpPr>
            <p:spPr>
              <a:xfrm>
                <a:off x="9238393" y="2384081"/>
                <a:ext cx="2844000" cy="0"/>
              </a:xfrm>
              <a:prstGeom prst="line">
                <a:avLst/>
              </a:prstGeom>
              <a:ln w="76200"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Gerader Verbinder 145"/>
              <p:cNvCxnSpPr/>
              <p:nvPr/>
            </p:nvCxnSpPr>
            <p:spPr>
              <a:xfrm>
                <a:off x="6970393" y="2384081"/>
                <a:ext cx="2268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Gerade Verbindung mit Pfeil 146"/>
              <p:cNvCxnSpPr/>
              <p:nvPr/>
            </p:nvCxnSpPr>
            <p:spPr>
              <a:xfrm flipV="1">
                <a:off x="7906393" y="2281506"/>
                <a:ext cx="828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Gerade Verbindung mit Pfeil 147"/>
              <p:cNvCxnSpPr/>
              <p:nvPr/>
            </p:nvCxnSpPr>
            <p:spPr>
              <a:xfrm flipV="1">
                <a:off x="8914393" y="2281506"/>
                <a:ext cx="61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Gerade Verbindung mit Pfeil 148"/>
              <p:cNvCxnSpPr/>
              <p:nvPr/>
            </p:nvCxnSpPr>
            <p:spPr>
              <a:xfrm flipV="1">
                <a:off x="10390393" y="2281506"/>
                <a:ext cx="79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" name="Rechteck 142"/>
            <p:cNvSpPr/>
            <p:nvPr/>
          </p:nvSpPr>
          <p:spPr>
            <a:xfrm>
              <a:off x="6882646" y="2882872"/>
              <a:ext cx="4493236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GAAGGAAAAATTGTCCATCTTGTCGT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CTTCGGAAATGTTATGAAGCAGG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GATG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CTCTGGGA</a:t>
              </a:r>
              <a:r>
                <a:rPr lang="en-US" sz="1050" b="1" u="sng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G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CAACTTA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CCTGAGCAAGCTGCTTTTTGGAG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CATTTGCACATCTTTTGGGATC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</a:rPr>
                <a:t>ACGTTGTTAAGAAGTAGAACTAAGG‑3’</a:t>
              </a:r>
              <a:endPara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feld 143"/>
            <p:cNvSpPr txBox="1"/>
            <p:nvPr/>
          </p:nvSpPr>
          <p:spPr>
            <a:xfrm>
              <a:off x="6882645" y="1969748"/>
              <a:ext cx="13612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91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4" name="Gruppieren 123"/>
          <p:cNvGrpSpPr/>
          <p:nvPr/>
        </p:nvGrpSpPr>
        <p:grpSpPr>
          <a:xfrm>
            <a:off x="569216" y="6859336"/>
            <a:ext cx="4493237" cy="1490205"/>
            <a:chOff x="6882645" y="281109"/>
            <a:chExt cx="4493237" cy="1490205"/>
          </a:xfrm>
        </p:grpSpPr>
        <p:sp>
          <p:nvSpPr>
            <p:cNvPr id="125" name="Rechteck 124"/>
            <p:cNvSpPr/>
            <p:nvPr/>
          </p:nvSpPr>
          <p:spPr>
            <a:xfrm>
              <a:off x="10378770" y="1261110"/>
              <a:ext cx="181234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6882645" y="708587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10404141" y="708585"/>
              <a:ext cx="9717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ryptic exon 3</a:t>
              </a:r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6882645" y="992806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23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129" name="Gruppieren 128"/>
            <p:cNvGrpSpPr/>
            <p:nvPr/>
          </p:nvGrpSpPr>
          <p:grpSpPr>
            <a:xfrm>
              <a:off x="6970393" y="592867"/>
              <a:ext cx="4320000" cy="102575"/>
              <a:chOff x="6970393" y="592867"/>
              <a:chExt cx="4428000" cy="102575"/>
            </a:xfrm>
          </p:grpSpPr>
          <p:cxnSp>
            <p:nvCxnSpPr>
              <p:cNvPr id="132" name="Gerader Verbinder 131"/>
              <p:cNvCxnSpPr/>
              <p:nvPr/>
            </p:nvCxnSpPr>
            <p:spPr>
              <a:xfrm>
                <a:off x="6970393" y="695442"/>
                <a:ext cx="1476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Gerader Verbinder 132"/>
              <p:cNvCxnSpPr/>
              <p:nvPr/>
            </p:nvCxnSpPr>
            <p:spPr>
              <a:xfrm>
                <a:off x="8446393" y="695442"/>
                <a:ext cx="2952000" cy="0"/>
              </a:xfrm>
              <a:prstGeom prst="line">
                <a:avLst/>
              </a:prstGeom>
              <a:ln w="76200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Gerade Verbindung mit Pfeil 133"/>
              <p:cNvCxnSpPr/>
              <p:nvPr/>
            </p:nvCxnSpPr>
            <p:spPr>
              <a:xfrm flipV="1">
                <a:off x="7906393" y="592867"/>
                <a:ext cx="828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Gerade Verbindung mit Pfeil 134"/>
              <p:cNvCxnSpPr/>
              <p:nvPr/>
            </p:nvCxnSpPr>
            <p:spPr>
              <a:xfrm flipV="1">
                <a:off x="9022393" y="592867"/>
                <a:ext cx="61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Gerade Verbindung mit Pfeil 135"/>
              <p:cNvCxnSpPr/>
              <p:nvPr/>
            </p:nvCxnSpPr>
            <p:spPr>
              <a:xfrm flipV="1">
                <a:off x="9670393" y="592867"/>
                <a:ext cx="79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0" name="Rechteck 129"/>
            <p:cNvSpPr/>
            <p:nvPr/>
          </p:nvSpPr>
          <p:spPr>
            <a:xfrm>
              <a:off x="6882646" y="1194233"/>
              <a:ext cx="4493236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CGTCTTCGGAAATGTTATGAAGC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GGATGACTCTGGGA</a:t>
              </a:r>
              <a:r>
                <a:rPr lang="en-US" sz="1050" b="1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AAATTC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GGGTTGG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AATTGCAAGCATCTCA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ATGACCAGACCCTGAAGAAAG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CTGACTTGCCTCATTCAAAATGAGG‑3’</a:t>
              </a:r>
              <a:endPara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feld 130"/>
            <p:cNvSpPr txBox="1"/>
            <p:nvPr/>
          </p:nvSpPr>
          <p:spPr>
            <a:xfrm>
              <a:off x="6882645" y="281109"/>
              <a:ext cx="13612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71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Gruppieren 107"/>
          <p:cNvGrpSpPr/>
          <p:nvPr/>
        </p:nvGrpSpPr>
        <p:grpSpPr>
          <a:xfrm>
            <a:off x="549282" y="4705937"/>
            <a:ext cx="4512165" cy="1651788"/>
            <a:chOff x="575290" y="4311653"/>
            <a:chExt cx="4512165" cy="1651788"/>
          </a:xfrm>
        </p:grpSpPr>
        <p:sp>
          <p:nvSpPr>
            <p:cNvPr id="109" name="Rechteck 108"/>
            <p:cNvSpPr/>
            <p:nvPr/>
          </p:nvSpPr>
          <p:spPr>
            <a:xfrm>
              <a:off x="2011454" y="5455933"/>
              <a:ext cx="180000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0" name="Textfeld 109"/>
            <p:cNvSpPr txBox="1"/>
            <p:nvPr/>
          </p:nvSpPr>
          <p:spPr>
            <a:xfrm>
              <a:off x="575290" y="4739131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2</a:t>
              </a:r>
            </a:p>
          </p:txBody>
        </p:sp>
        <p:sp>
          <p:nvSpPr>
            <p:cNvPr id="112" name="Textfeld 111"/>
            <p:cNvSpPr txBox="1"/>
            <p:nvPr/>
          </p:nvSpPr>
          <p:spPr>
            <a:xfrm>
              <a:off x="4110880" y="4739129"/>
              <a:ext cx="9717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ryptic exon 4</a:t>
              </a:r>
            </a:p>
          </p:txBody>
        </p:sp>
        <p:sp>
          <p:nvSpPr>
            <p:cNvPr id="115" name="Textfeld 114"/>
            <p:cNvSpPr txBox="1"/>
            <p:nvPr/>
          </p:nvSpPr>
          <p:spPr>
            <a:xfrm>
              <a:off x="575290" y="5023350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70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116" name="Gruppieren 115"/>
            <p:cNvGrpSpPr/>
            <p:nvPr/>
          </p:nvGrpSpPr>
          <p:grpSpPr>
            <a:xfrm>
              <a:off x="663038" y="4623411"/>
              <a:ext cx="4321318" cy="102575"/>
              <a:chOff x="663038" y="4623411"/>
              <a:chExt cx="6121870" cy="102575"/>
            </a:xfrm>
          </p:grpSpPr>
          <p:cxnSp>
            <p:nvCxnSpPr>
              <p:cNvPr id="119" name="Gerader Verbinder 118"/>
              <p:cNvCxnSpPr/>
              <p:nvPr/>
            </p:nvCxnSpPr>
            <p:spPr>
              <a:xfrm>
                <a:off x="3138406" y="4725986"/>
                <a:ext cx="3646502" cy="0"/>
              </a:xfrm>
              <a:prstGeom prst="line">
                <a:avLst/>
              </a:prstGeom>
              <a:ln w="76200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Gerader Verbinder 119"/>
              <p:cNvCxnSpPr/>
              <p:nvPr/>
            </p:nvCxnSpPr>
            <p:spPr>
              <a:xfrm>
                <a:off x="663038" y="4725986"/>
                <a:ext cx="2484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Gerade Verbindung mit Pfeil 120"/>
              <p:cNvCxnSpPr/>
              <p:nvPr/>
            </p:nvCxnSpPr>
            <p:spPr>
              <a:xfrm flipV="1">
                <a:off x="1563038" y="4623411"/>
                <a:ext cx="72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Gerade Verbindung mit Pfeil 121"/>
              <p:cNvCxnSpPr/>
              <p:nvPr/>
            </p:nvCxnSpPr>
            <p:spPr>
              <a:xfrm flipV="1">
                <a:off x="2751038" y="4623411"/>
                <a:ext cx="54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Gerade Verbindung mit Pfeil 122"/>
              <p:cNvCxnSpPr/>
              <p:nvPr/>
            </p:nvCxnSpPr>
            <p:spPr>
              <a:xfrm flipV="1">
                <a:off x="4407038" y="4623411"/>
                <a:ext cx="720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7" name="Rechteck 116"/>
            <p:cNvSpPr/>
            <p:nvPr/>
          </p:nvSpPr>
          <p:spPr>
            <a:xfrm>
              <a:off x="575291" y="5224777"/>
              <a:ext cx="4512164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TTCTGGGTGTCACTATGGAGCTCT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ACATGTGGAAGCTGCAAGG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CTTCTTCAAAAG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GCCGCTGAA</a:t>
              </a:r>
              <a:r>
                <a:rPr lang="en-US" sz="1050" b="1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G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TT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TTCAGAATGAACAAATTAAAAGAATCATAATCAGACACTAACCCCAAGCC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TACTGCATGGCAGCACCAA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GGGACTGACAGAAAACAACAGAAAT‑3’</a:t>
              </a:r>
              <a:endPara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Textfeld 117"/>
            <p:cNvSpPr txBox="1"/>
            <p:nvPr/>
          </p:nvSpPr>
          <p:spPr>
            <a:xfrm>
              <a:off x="575290" y="4311653"/>
              <a:ext cx="14318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119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feld 9">
            <a:extLst>
              <a:ext uri="{FF2B5EF4-FFF2-40B4-BE49-F238E27FC236}">
                <a16:creationId xmlns:a16="http://schemas.microsoft.com/office/drawing/2014/main" id="{FE69CA29-F040-A945-B2D3-EBB612BEC317}"/>
              </a:ext>
            </a:extLst>
          </p:cNvPr>
          <p:cNvSpPr txBox="1"/>
          <p:nvPr/>
        </p:nvSpPr>
        <p:spPr>
          <a:xfrm>
            <a:off x="0" y="4236"/>
            <a:ext cx="33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ig. S2 </a:t>
            </a:r>
            <a:r>
              <a:rPr lang="en-GB" sz="1400" dirty="0"/>
              <a:t>cDNA copy number determination</a:t>
            </a:r>
            <a:endParaRPr lang="de-DE" sz="1400" b="1" dirty="0"/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D336D59-0F38-4747-B7E7-918F83B652CF}"/>
              </a:ext>
            </a:extLst>
          </p:cNvPr>
          <p:cNvSpPr txBox="1"/>
          <p:nvPr/>
        </p:nvSpPr>
        <p:spPr>
          <a:xfrm rot="16200000">
            <a:off x="-227271" y="1313912"/>
            <a:ext cx="1174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KLK3-PSA</a:t>
            </a:r>
          </a:p>
        </p:txBody>
      </p:sp>
      <p:grpSp>
        <p:nvGrpSpPr>
          <p:cNvPr id="39" name="Gruppieren 38"/>
          <p:cNvGrpSpPr/>
          <p:nvPr/>
        </p:nvGrpSpPr>
        <p:grpSpPr>
          <a:xfrm>
            <a:off x="553044" y="691343"/>
            <a:ext cx="4514579" cy="1522137"/>
            <a:chOff x="572875" y="254783"/>
            <a:chExt cx="4514579" cy="1522137"/>
          </a:xfrm>
        </p:grpSpPr>
        <p:sp>
          <p:nvSpPr>
            <p:cNvPr id="40" name="Rechteck 39"/>
            <p:cNvSpPr/>
            <p:nvPr/>
          </p:nvSpPr>
          <p:spPr>
            <a:xfrm>
              <a:off x="1759579" y="1429963"/>
              <a:ext cx="180000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41" name="Gruppieren 40"/>
            <p:cNvGrpSpPr/>
            <p:nvPr/>
          </p:nvGrpSpPr>
          <p:grpSpPr>
            <a:xfrm>
              <a:off x="664272" y="665744"/>
              <a:ext cx="4309840" cy="0"/>
              <a:chOff x="5301765" y="1652262"/>
              <a:chExt cx="4309840" cy="0"/>
            </a:xfrm>
          </p:grpSpPr>
          <p:cxnSp>
            <p:nvCxnSpPr>
              <p:cNvPr id="48" name="Gerader Verbinder 47"/>
              <p:cNvCxnSpPr/>
              <p:nvPr/>
            </p:nvCxnSpPr>
            <p:spPr>
              <a:xfrm>
                <a:off x="5301765" y="1652262"/>
                <a:ext cx="2160000" cy="0"/>
              </a:xfrm>
              <a:prstGeom prst="line">
                <a:avLst/>
              </a:prstGeom>
              <a:ln w="762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Gerader Verbinder 48"/>
              <p:cNvCxnSpPr/>
              <p:nvPr/>
            </p:nvCxnSpPr>
            <p:spPr>
              <a:xfrm>
                <a:off x="7451605" y="1652262"/>
                <a:ext cx="2160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Textfeld 41"/>
            <p:cNvSpPr txBox="1"/>
            <p:nvPr/>
          </p:nvSpPr>
          <p:spPr>
            <a:xfrm>
              <a:off x="572875" y="670095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2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4521273" y="670093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572875" y="1005836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32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5" name="Rechteck 44"/>
            <p:cNvSpPr/>
            <p:nvPr/>
          </p:nvSpPr>
          <p:spPr>
            <a:xfrm>
              <a:off x="572876" y="1199839"/>
              <a:ext cx="4506119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GGCAGTCTGCGGCGGTGTTCTGGTGCACCCCCAGTGGGTCCTCACAGCTGCCCACTGCATCAGGA</a:t>
              </a:r>
              <a:r>
                <a:rPr lang="en-US" sz="1050" b="1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</a:t>
              </a:r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AAAGCGTGATCTTGCTGGGTCGGCACAGCCTGTTTCATCCTGAAGACACAGGCCAGGTATTTCA‑3’</a:t>
              </a:r>
              <a:endPara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584706" y="254783"/>
              <a:ext cx="30091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64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; targeted region confidential</a:t>
              </a:r>
            </a:p>
          </p:txBody>
        </p:sp>
        <p:cxnSp>
          <p:nvCxnSpPr>
            <p:cNvPr id="47" name="Gerader Verbinder 46"/>
            <p:cNvCxnSpPr/>
            <p:nvPr/>
          </p:nvCxnSpPr>
          <p:spPr>
            <a:xfrm>
              <a:off x="1257718" y="565656"/>
              <a:ext cx="3132000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Textfeld 50">
            <a:extLst>
              <a:ext uri="{FF2B5EF4-FFF2-40B4-BE49-F238E27FC236}">
                <a16:creationId xmlns:a16="http://schemas.microsoft.com/office/drawing/2014/main" id="{AEC75F64-C29F-4115-9C47-53D7692F9B81}"/>
              </a:ext>
            </a:extLst>
          </p:cNvPr>
          <p:cNvSpPr txBox="1"/>
          <p:nvPr/>
        </p:nvSpPr>
        <p:spPr>
          <a:xfrm rot="16200000">
            <a:off x="-191168" y="3372725"/>
            <a:ext cx="1102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R-FL</a:t>
            </a:r>
          </a:p>
        </p:txBody>
      </p:sp>
      <p:grpSp>
        <p:nvGrpSpPr>
          <p:cNvPr id="52" name="Gruppieren 51"/>
          <p:cNvGrpSpPr/>
          <p:nvPr/>
        </p:nvGrpSpPr>
        <p:grpSpPr>
          <a:xfrm>
            <a:off x="551248" y="2673789"/>
            <a:ext cx="4514580" cy="1674871"/>
            <a:chOff x="572875" y="2421975"/>
            <a:chExt cx="4514580" cy="1674871"/>
          </a:xfrm>
        </p:grpSpPr>
        <p:sp>
          <p:nvSpPr>
            <p:cNvPr id="53" name="Rechteck 52"/>
            <p:cNvSpPr/>
            <p:nvPr/>
          </p:nvSpPr>
          <p:spPr>
            <a:xfrm>
              <a:off x="3038760" y="3567365"/>
              <a:ext cx="180000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54" name="Gruppieren 53"/>
            <p:cNvGrpSpPr/>
            <p:nvPr/>
          </p:nvGrpSpPr>
          <p:grpSpPr>
            <a:xfrm>
              <a:off x="664272" y="2841323"/>
              <a:ext cx="4309840" cy="0"/>
              <a:chOff x="5301765" y="1652262"/>
              <a:chExt cx="4309840" cy="0"/>
            </a:xfrm>
          </p:grpSpPr>
          <p:cxnSp>
            <p:nvCxnSpPr>
              <p:cNvPr id="61" name="Gerader Verbinder 60"/>
              <p:cNvCxnSpPr/>
              <p:nvPr/>
            </p:nvCxnSpPr>
            <p:spPr>
              <a:xfrm>
                <a:off x="5301765" y="1652262"/>
                <a:ext cx="2160000" cy="0"/>
              </a:xfrm>
              <a:prstGeom prst="line">
                <a:avLst/>
              </a:prstGeom>
              <a:ln w="762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Gerader Verbinder 61"/>
              <p:cNvCxnSpPr/>
              <p:nvPr/>
            </p:nvCxnSpPr>
            <p:spPr>
              <a:xfrm>
                <a:off x="7451605" y="1652262"/>
                <a:ext cx="2160000" cy="0"/>
              </a:xfrm>
              <a:prstGeom prst="line">
                <a:avLst/>
              </a:prstGeom>
              <a:ln w="762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5" name="Gerader Verbinder 54"/>
            <p:cNvCxnSpPr/>
            <p:nvPr/>
          </p:nvCxnSpPr>
          <p:spPr>
            <a:xfrm>
              <a:off x="1230145" y="2741235"/>
              <a:ext cx="3132000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feld 55"/>
            <p:cNvSpPr txBox="1"/>
            <p:nvPr/>
          </p:nvSpPr>
          <p:spPr>
            <a:xfrm>
              <a:off x="572875" y="2849453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4</a:t>
              </a: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4521273" y="2849451"/>
              <a:ext cx="5661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5</a:t>
              </a: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576110" y="3133672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70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9" name="Rechteck 58"/>
            <p:cNvSpPr/>
            <p:nvPr/>
          </p:nvSpPr>
          <p:spPr>
            <a:xfrm>
              <a:off x="572875" y="3335099"/>
              <a:ext cx="4506120" cy="7617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</a:t>
              </a:r>
              <a:r>
                <a:rPr lang="en-GB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TTGCAGCCTTGCTCTCTAGCCTCAATGAACTGGGAGAGAGACAGCTTGTACACGTGGTCAAGTGGGCCAAGGCCTTGCCT</a:t>
              </a:r>
              <a:r>
                <a:rPr lang="en-GB" sz="1050" b="1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G</a:t>
              </a:r>
              <a:r>
                <a:rPr lang="en-GB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TTCCGCAACTTACACGTGGACGACCAGATGGCTGTCATTCAGTACTCCTGGATGGGGCTCATGGTGTTTGCCATGGGCTGGCGATC‑3’</a:t>
              </a:r>
              <a:endParaRPr lang="de-DE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584706" y="2421975"/>
              <a:ext cx="29674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72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; targeted region confidential</a:t>
              </a:r>
            </a:p>
          </p:txBody>
        </p:sp>
      </p:grpSp>
      <p:sp>
        <p:nvSpPr>
          <p:cNvPr id="64" name="Textfeld 63">
            <a:extLst>
              <a:ext uri="{FF2B5EF4-FFF2-40B4-BE49-F238E27FC236}">
                <a16:creationId xmlns:a16="http://schemas.microsoft.com/office/drawing/2014/main" id="{AEC75F64-C29F-4115-9C47-53D7692F9B81}"/>
              </a:ext>
            </a:extLst>
          </p:cNvPr>
          <p:cNvSpPr txBox="1"/>
          <p:nvPr/>
        </p:nvSpPr>
        <p:spPr>
          <a:xfrm rot="16200000">
            <a:off x="-157292" y="7476153"/>
            <a:ext cx="10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R-V7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AEC75F64-C29F-4115-9C47-53D7692F9B81}"/>
              </a:ext>
            </a:extLst>
          </p:cNvPr>
          <p:cNvSpPr txBox="1"/>
          <p:nvPr/>
        </p:nvSpPr>
        <p:spPr>
          <a:xfrm rot="16200000">
            <a:off x="-207461" y="5393332"/>
            <a:ext cx="1144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R-V3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AEC75F64-C29F-4115-9C47-53D7692F9B81}"/>
              </a:ext>
            </a:extLst>
          </p:cNvPr>
          <p:cNvSpPr txBox="1"/>
          <p:nvPr/>
        </p:nvSpPr>
        <p:spPr>
          <a:xfrm rot="16200000">
            <a:off x="-165328" y="9491061"/>
            <a:ext cx="1075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R-V9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4975500" y="446497"/>
            <a:ext cx="2812888" cy="10378800"/>
            <a:chOff x="389840" y="453000"/>
            <a:chExt cx="2812888" cy="10378800"/>
          </a:xfrm>
        </p:grpSpPr>
        <p:graphicFrame>
          <p:nvGraphicFramePr>
            <p:cNvPr id="76" name="Objekt 75">
              <a:extLst>
                <a:ext uri="{FF2B5EF4-FFF2-40B4-BE49-F238E27FC236}">
                  <a16:creationId xmlns:a16="http://schemas.microsoft.com/office/drawing/2014/main" id="{720A97A9-F680-4046-8238-A133D1F1E38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5206029"/>
                </p:ext>
              </p:extLst>
            </p:nvPr>
          </p:nvGraphicFramePr>
          <p:xfrm>
            <a:off x="389840" y="453000"/>
            <a:ext cx="2812888" cy="1037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57" name="Prism 8" r:id="rId4" imgW="2533915" imgH="9352120" progId="Prism8.Document">
                    <p:embed/>
                  </p:oleObj>
                </mc:Choice>
                <mc:Fallback>
                  <p:oleObj name="Prism 8" r:id="rId4" imgW="2533915" imgH="9352120" progId="Prism8.Document">
                    <p:embed/>
                    <p:pic>
                      <p:nvPicPr>
                        <p:cNvPr id="76" name="Objekt 75">
                          <a:extLst>
                            <a:ext uri="{FF2B5EF4-FFF2-40B4-BE49-F238E27FC236}">
                              <a16:creationId xmlns:a16="http://schemas.microsoft.com/office/drawing/2014/main" id="{720A97A9-F680-4046-8238-A133D1F1E38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89840" y="453000"/>
                          <a:ext cx="2812888" cy="1037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5" name="Rechteck 74"/>
            <p:cNvSpPr/>
            <p:nvPr/>
          </p:nvSpPr>
          <p:spPr>
            <a:xfrm>
              <a:off x="943975" y="1684061"/>
              <a:ext cx="1196016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 sz="1000" b="0" i="0" u="none" strike="noStrike" kern="1200" baseline="0">
                  <a:solidFill>
                    <a:srgbClr val="000000"/>
                  </a:solidFill>
                  <a:latin typeface="Calibri"/>
                  <a:ea typeface="Calibri"/>
                  <a:cs typeface="Calibri"/>
                </a:defRPr>
              </a:pPr>
              <a:r>
                <a:rPr lang="en-US" sz="900" dirty="0"/>
                <a:t>y = -3,98x + 44,86</a:t>
              </a:r>
              <a:br>
                <a:rPr lang="en-US" sz="900" dirty="0"/>
              </a:br>
              <a:r>
                <a:rPr lang="en-US" sz="900" dirty="0"/>
                <a:t>R² = 0,9965</a:t>
              </a:r>
            </a:p>
          </p:txBody>
        </p:sp>
        <p:sp>
          <p:nvSpPr>
            <p:cNvPr id="77" name="Rechteck 76"/>
            <p:cNvSpPr/>
            <p:nvPr/>
          </p:nvSpPr>
          <p:spPr>
            <a:xfrm>
              <a:off x="943975" y="3733655"/>
              <a:ext cx="144942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/>
                <a:t>y = -3,65x + 40,09</a:t>
              </a:r>
              <a:br>
                <a:rPr lang="en-US" sz="900" dirty="0"/>
              </a:br>
              <a:r>
                <a:rPr lang="en-US" sz="900" dirty="0"/>
                <a:t>R² = 0,9998</a:t>
              </a:r>
            </a:p>
          </p:txBody>
        </p:sp>
        <p:sp>
          <p:nvSpPr>
            <p:cNvPr id="78" name="Rechteck 77"/>
            <p:cNvSpPr/>
            <p:nvPr/>
          </p:nvSpPr>
          <p:spPr>
            <a:xfrm>
              <a:off x="943975" y="5789890"/>
              <a:ext cx="144942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 sz="9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900" dirty="0"/>
                <a:t>y = -3,30x + 41,66</a:t>
              </a:r>
              <a:br>
                <a:rPr lang="en-US" sz="900" dirty="0"/>
              </a:br>
              <a:r>
                <a:rPr lang="en-US" sz="900" dirty="0"/>
                <a:t>R² = 0,9981</a:t>
              </a:r>
            </a:p>
          </p:txBody>
        </p:sp>
        <p:sp>
          <p:nvSpPr>
            <p:cNvPr id="80" name="Rechteck 79"/>
            <p:cNvSpPr/>
            <p:nvPr/>
          </p:nvSpPr>
          <p:spPr>
            <a:xfrm>
              <a:off x="943975" y="7834996"/>
              <a:ext cx="144942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 sz="9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r>
                <a:rPr lang="de-DE" sz="900" dirty="0"/>
                <a:t>y = -3,28x + 41,47</a:t>
              </a:r>
              <a:br>
                <a:rPr lang="de-DE" sz="900" dirty="0"/>
              </a:br>
              <a:r>
                <a:rPr lang="de-DE" sz="900" dirty="0"/>
                <a:t>R² = 0,9931</a:t>
              </a:r>
            </a:p>
          </p:txBody>
        </p:sp>
        <p:sp>
          <p:nvSpPr>
            <p:cNvPr id="81" name="Rechteck 80"/>
            <p:cNvSpPr/>
            <p:nvPr/>
          </p:nvSpPr>
          <p:spPr>
            <a:xfrm>
              <a:off x="943975" y="9876935"/>
              <a:ext cx="144942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 sz="9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r>
                <a:rPr lang="de-DE" sz="900" dirty="0"/>
                <a:t>y = -3,437x + 40,23</a:t>
              </a:r>
              <a:br>
                <a:rPr lang="de-DE" sz="900" dirty="0"/>
              </a:br>
              <a:r>
                <a:rPr lang="de-DE" sz="900" dirty="0"/>
                <a:t>R² = 0,997</a:t>
              </a:r>
            </a:p>
          </p:txBody>
        </p:sp>
      </p:grpSp>
      <p:sp>
        <p:nvSpPr>
          <p:cNvPr id="3" name="Rechteck 2"/>
          <p:cNvSpPr/>
          <p:nvPr/>
        </p:nvSpPr>
        <p:spPr>
          <a:xfrm>
            <a:off x="6159193" y="611683"/>
            <a:ext cx="605307" cy="253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echteck 92"/>
          <p:cNvSpPr/>
          <p:nvPr/>
        </p:nvSpPr>
        <p:spPr>
          <a:xfrm>
            <a:off x="6157862" y="2646358"/>
            <a:ext cx="605307" cy="253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1" name="Rechteck 110"/>
          <p:cNvSpPr/>
          <p:nvPr/>
        </p:nvSpPr>
        <p:spPr>
          <a:xfrm>
            <a:off x="6091746" y="4700818"/>
            <a:ext cx="605307" cy="253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3" name="Rechteck 112"/>
          <p:cNvSpPr/>
          <p:nvPr/>
        </p:nvSpPr>
        <p:spPr>
          <a:xfrm>
            <a:off x="6091746" y="6757245"/>
            <a:ext cx="605307" cy="253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4" name="Rechteck 113"/>
          <p:cNvSpPr/>
          <p:nvPr/>
        </p:nvSpPr>
        <p:spPr>
          <a:xfrm>
            <a:off x="6085456" y="8805811"/>
            <a:ext cx="605307" cy="253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899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9</Words>
  <Application>Microsoft Office PowerPoint</Application>
  <PresentationFormat>Benutzerdefiniert</PresentationFormat>
  <Paragraphs>37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Wüstmann, Neele Elisabeth</cp:lastModifiedBy>
  <cp:revision>315</cp:revision>
  <cp:lastPrinted>2022-01-26T09:42:13Z</cp:lastPrinted>
  <dcterms:created xsi:type="dcterms:W3CDTF">2021-11-18T14:50:58Z</dcterms:created>
  <dcterms:modified xsi:type="dcterms:W3CDTF">2023-02-24T10:38:19Z</dcterms:modified>
</cp:coreProperties>
</file>